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5" d="100"/>
          <a:sy n="125" d="100"/>
        </p:scale>
        <p:origin x="1157" y="-4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0224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3968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1322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6317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7652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9749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7662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8755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77961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05529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17506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1797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B64687C9-A607-4FDB-8CF8-D15E5CC99E16}"/>
              </a:ext>
            </a:extLst>
          </p:cNvPr>
          <p:cNvGrpSpPr/>
          <p:nvPr/>
        </p:nvGrpSpPr>
        <p:grpSpPr>
          <a:xfrm>
            <a:off x="9703" y="0"/>
            <a:ext cx="6378397" cy="4694690"/>
            <a:chOff x="9703" y="147735"/>
            <a:chExt cx="6378397" cy="4694690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99241CA2-34D6-4702-86E1-56D83793EA2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4650" y="332337"/>
              <a:ext cx="6013450" cy="4510088"/>
            </a:xfrm>
            <a:prstGeom prst="rect">
              <a:avLst/>
            </a:prstGeom>
          </p:spPr>
        </p:pic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83138ECB-B620-4633-97B6-1740D08DF11A}"/>
                </a:ext>
              </a:extLst>
            </p:cNvPr>
            <p:cNvSpPr txBox="1"/>
            <p:nvPr/>
          </p:nvSpPr>
          <p:spPr>
            <a:xfrm>
              <a:off x="9703" y="147735"/>
              <a:ext cx="231597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" name="组合 5">
            <a:extLst>
              <a:ext uri="{FF2B5EF4-FFF2-40B4-BE49-F238E27FC236}">
                <a16:creationId xmlns:a16="http://schemas.microsoft.com/office/drawing/2014/main" id="{82FB0ED0-6B8B-43C5-9799-C2209654726F}"/>
              </a:ext>
            </a:extLst>
          </p:cNvPr>
          <p:cNvGrpSpPr/>
          <p:nvPr/>
        </p:nvGrpSpPr>
        <p:grpSpPr>
          <a:xfrm>
            <a:off x="9703" y="4485176"/>
            <a:ext cx="6489700" cy="4775652"/>
            <a:chOff x="0" y="177348"/>
            <a:chExt cx="6489700" cy="4775652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0B27605F-D6FB-445F-BBF4-74FC01575F9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8300" y="361950"/>
              <a:ext cx="6121400" cy="4591050"/>
            </a:xfrm>
            <a:prstGeom prst="rect">
              <a:avLst/>
            </a:prstGeom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1E5C91C0-CAB8-4B68-8492-5E928C2B07EC}"/>
                </a:ext>
              </a:extLst>
            </p:cNvPr>
            <p:cNvSpPr txBox="1"/>
            <p:nvPr/>
          </p:nvSpPr>
          <p:spPr>
            <a:xfrm>
              <a:off x="0" y="177348"/>
              <a:ext cx="231597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" name="文本框 8">
            <a:extLst>
              <a:ext uri="{FF2B5EF4-FFF2-40B4-BE49-F238E27FC236}">
                <a16:creationId xmlns:a16="http://schemas.microsoft.com/office/drawing/2014/main" id="{5B69AAE8-085D-444A-B38A-FC7A58EAD0A4}"/>
              </a:ext>
            </a:extLst>
          </p:cNvPr>
          <p:cNvSpPr txBox="1"/>
          <p:nvPr/>
        </p:nvSpPr>
        <p:spPr>
          <a:xfrm>
            <a:off x="266700" y="9290575"/>
            <a:ext cx="6121400" cy="8616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</a:t>
            </a:r>
            <a:r>
              <a:rPr lang="en-US" altLang="zh-CN" sz="1400" b="1" ker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3</a:t>
            </a:r>
            <a:r>
              <a:rPr lang="en-US" altLang="zh-CN" sz="14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4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,B)</a:t>
            </a:r>
            <a:r>
              <a:rPr lang="en-US" altLang="zh-CN" sz="14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IDE analysis for predicting the likelihood of clinical response to immune checkpoint inhibitors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478214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思涵</dc:creator>
  <cp:lastModifiedBy>MDPI</cp:lastModifiedBy>
  <cp:revision>4</cp:revision>
  <dcterms:created xsi:type="dcterms:W3CDTF">2022-05-01T05:12:34Z</dcterms:created>
  <dcterms:modified xsi:type="dcterms:W3CDTF">2022-08-30T11:09:06Z</dcterms:modified>
</cp:coreProperties>
</file>